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5266"/>
    <p:restoredTop sz="94694"/>
  </p:normalViewPr>
  <p:slideViewPr>
    <p:cSldViewPr snapToGrid="0" snapToObjects="1">
      <p:cViewPr varScale="1">
        <p:scale>
          <a:sx n="137" d="100"/>
          <a:sy n="137" d="100"/>
        </p:scale>
        <p:origin x="236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Mike/Downloads/figures/county%20estimate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Mike/Downloads/figures/county%20estimate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Mike/Downloads/figures/county%20estimate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Mike/Downloads/figures/county%20estimate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46500188028203054"/>
          <c:y val="0.2305197909363248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1" i="0" u="none" strike="noStrike" kern="1200" spc="0" baseline="0">
              <a:solidFill>
                <a:schemeClr val="tx1"/>
              </a:solidFill>
              <a:latin typeface="Calibri" panose="020F0502020204030204" pitchFamily="34" charset="0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heet 1 - county estimates'!$A$31</c:f>
              <c:strCache>
                <c:ptCount val="1"/>
                <c:pt idx="0">
                  <c:v>Cheyenn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heet 1 - county estimates'!$B$69:$J$69</c:f>
                <c:numCache>
                  <c:formatCode>General</c:formatCode>
                  <c:ptCount val="9"/>
                  <c:pt idx="0">
                    <c:v>2.81727025714806E-2</c:v>
                  </c:pt>
                  <c:pt idx="1">
                    <c:v>1.33244498287065E-2</c:v>
                  </c:pt>
                  <c:pt idx="2">
                    <c:v>1.6038494334447002E-2</c:v>
                  </c:pt>
                  <c:pt idx="3">
                    <c:v>8.9647705003348798E-3</c:v>
                  </c:pt>
                  <c:pt idx="4">
                    <c:v>5.8547311674482802E-3</c:v>
                  </c:pt>
                  <c:pt idx="5">
                    <c:v>2.46828071798703E-2</c:v>
                  </c:pt>
                  <c:pt idx="6">
                    <c:v>7.09656590461369E-2</c:v>
                  </c:pt>
                  <c:pt idx="7">
                    <c:v>2.88459818289423E-2</c:v>
                  </c:pt>
                  <c:pt idx="8">
                    <c:v>4.4667756647052297E-2</c:v>
                  </c:pt>
                </c:numCache>
              </c:numRef>
            </c:plus>
            <c:minus>
              <c:numRef>
                <c:f>'Sheet 1 - county estimates'!$B$69:$J$69</c:f>
                <c:numCache>
                  <c:formatCode>General</c:formatCode>
                  <c:ptCount val="9"/>
                  <c:pt idx="0">
                    <c:v>2.81727025714806E-2</c:v>
                  </c:pt>
                  <c:pt idx="1">
                    <c:v>1.33244498287065E-2</c:v>
                  </c:pt>
                  <c:pt idx="2">
                    <c:v>1.6038494334447002E-2</c:v>
                  </c:pt>
                  <c:pt idx="3">
                    <c:v>8.9647705003348798E-3</c:v>
                  </c:pt>
                  <c:pt idx="4">
                    <c:v>5.8547311674482802E-3</c:v>
                  </c:pt>
                  <c:pt idx="5">
                    <c:v>2.46828071798703E-2</c:v>
                  </c:pt>
                  <c:pt idx="6">
                    <c:v>7.09656590461369E-2</c:v>
                  </c:pt>
                  <c:pt idx="7">
                    <c:v>2.88459818289423E-2</c:v>
                  </c:pt>
                  <c:pt idx="8">
                    <c:v>4.466775664705229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heet 1 - county estimates'!$B$30:$J$30</c:f>
              <c:strCache>
                <c:ptCount val="9"/>
                <c:pt idx="0">
                  <c:v>May </c:v>
                </c:pt>
                <c:pt idx="1">
                  <c:v>June    2014</c:v>
                </c:pt>
                <c:pt idx="2">
                  <c:v>July </c:v>
                </c:pt>
                <c:pt idx="3">
                  <c:v>May </c:v>
                </c:pt>
                <c:pt idx="4">
                  <c:v>June    2015</c:v>
                </c:pt>
                <c:pt idx="5">
                  <c:v>July</c:v>
                </c:pt>
                <c:pt idx="6">
                  <c:v>May</c:v>
                </c:pt>
                <c:pt idx="7">
                  <c:v>June    2016</c:v>
                </c:pt>
                <c:pt idx="8">
                  <c:v>July </c:v>
                </c:pt>
              </c:strCache>
            </c:strRef>
          </c:cat>
          <c:val>
            <c:numRef>
              <c:f>'Sheet 1 - county estimates'!$B$31:$J$31</c:f>
              <c:numCache>
                <c:formatCode>General</c:formatCode>
                <c:ptCount val="9"/>
                <c:pt idx="0">
                  <c:v>0.31187507623897698</c:v>
                </c:pt>
                <c:pt idx="1">
                  <c:v>0.29312158918386699</c:v>
                </c:pt>
                <c:pt idx="2">
                  <c:v>0.474626654717618</c:v>
                </c:pt>
                <c:pt idx="3">
                  <c:v>9.4613344551016096E-2</c:v>
                </c:pt>
                <c:pt idx="4">
                  <c:v>7.1246103396171101E-2</c:v>
                </c:pt>
                <c:pt idx="5">
                  <c:v>0.434816972017118</c:v>
                </c:pt>
                <c:pt idx="6">
                  <c:v>0.347008537789946</c:v>
                </c:pt>
                <c:pt idx="7">
                  <c:v>0.38417321069377097</c:v>
                </c:pt>
                <c:pt idx="8">
                  <c:v>0.747631605340042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37E-1047-BE45-E39569E01C6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2748320"/>
        <c:axId val="142754552"/>
      </c:barChart>
      <c:catAx>
        <c:axId val="1427483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pPr>
            <a:endParaRPr lang="en-US"/>
          </a:p>
        </c:txPr>
        <c:crossAx val="142754552"/>
        <c:crosses val="autoZero"/>
        <c:auto val="1"/>
        <c:lblAlgn val="ctr"/>
        <c:lblOffset val="100"/>
        <c:noMultiLvlLbl val="0"/>
      </c:catAx>
      <c:valAx>
        <c:axId val="142754552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pPr>
            <a:endParaRPr lang="en-US"/>
          </a:p>
        </c:txPr>
        <c:crossAx val="142748320"/>
        <c:crosses val="autoZero"/>
        <c:crossBetween val="between"/>
        <c:majorUnit val="0.2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43202185135280102"/>
          <c:y val="0.2873007958269748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1" i="0" u="none" strike="noStrike" kern="1200" spc="0" baseline="0">
              <a:solidFill>
                <a:schemeClr val="tx1"/>
              </a:solidFill>
              <a:latin typeface="Calibri" panose="020F0502020204030204" pitchFamily="34" charset="0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heet 1 - county estimates'!$A$37</c:f>
              <c:strCache>
                <c:ptCount val="1"/>
                <c:pt idx="0">
                  <c:v>Saunder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heet 1 - county estimates'!$B$72:$J$72</c:f>
                <c:numCache>
                  <c:formatCode>General</c:formatCode>
                  <c:ptCount val="9"/>
                  <c:pt idx="0">
                    <c:v>8.7449923287915097E-3</c:v>
                  </c:pt>
                  <c:pt idx="1">
                    <c:v>5.3953803994194202E-3</c:v>
                  </c:pt>
                  <c:pt idx="2">
                    <c:v>5.7804579415839101E-2</c:v>
                  </c:pt>
                  <c:pt idx="3">
                    <c:v>3.8184873756964802E-3</c:v>
                  </c:pt>
                  <c:pt idx="4">
                    <c:v>1.82533207358069E-3</c:v>
                  </c:pt>
                  <c:pt idx="5">
                    <c:v>1.66565940097857E-2</c:v>
                  </c:pt>
                  <c:pt idx="6">
                    <c:v>1.99239544586833E-2</c:v>
                  </c:pt>
                  <c:pt idx="7">
                    <c:v>9.3423105444342108E-3</c:v>
                  </c:pt>
                  <c:pt idx="8">
                    <c:v>0.12925487233530999</c:v>
                  </c:pt>
                </c:numCache>
              </c:numRef>
            </c:plus>
            <c:minus>
              <c:numRef>
                <c:f>'Sheet 1 - county estimates'!$B$72:$J$72</c:f>
                <c:numCache>
                  <c:formatCode>General</c:formatCode>
                  <c:ptCount val="9"/>
                  <c:pt idx="0">
                    <c:v>8.7449923287915097E-3</c:v>
                  </c:pt>
                  <c:pt idx="1">
                    <c:v>5.3953803994194202E-3</c:v>
                  </c:pt>
                  <c:pt idx="2">
                    <c:v>5.7804579415839101E-2</c:v>
                  </c:pt>
                  <c:pt idx="3">
                    <c:v>3.8184873756964802E-3</c:v>
                  </c:pt>
                  <c:pt idx="4">
                    <c:v>1.82533207358069E-3</c:v>
                  </c:pt>
                  <c:pt idx="5">
                    <c:v>1.66565940097857E-2</c:v>
                  </c:pt>
                  <c:pt idx="6">
                    <c:v>1.99239544586833E-2</c:v>
                  </c:pt>
                  <c:pt idx="7">
                    <c:v>9.3423105444342108E-3</c:v>
                  </c:pt>
                  <c:pt idx="8">
                    <c:v>0.129254872335309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heet 1 - county estimates'!$B$36:$J$36</c:f>
              <c:strCache>
                <c:ptCount val="9"/>
                <c:pt idx="0">
                  <c:v>May </c:v>
                </c:pt>
                <c:pt idx="1">
                  <c:v>June    2014</c:v>
                </c:pt>
                <c:pt idx="2">
                  <c:v>July </c:v>
                </c:pt>
                <c:pt idx="3">
                  <c:v>May </c:v>
                </c:pt>
                <c:pt idx="4">
                  <c:v>June    2015</c:v>
                </c:pt>
                <c:pt idx="5">
                  <c:v>July</c:v>
                </c:pt>
                <c:pt idx="6">
                  <c:v>May</c:v>
                </c:pt>
                <c:pt idx="7">
                  <c:v>June    2016</c:v>
                </c:pt>
                <c:pt idx="8">
                  <c:v>July </c:v>
                </c:pt>
              </c:strCache>
            </c:strRef>
          </c:cat>
          <c:val>
            <c:numRef>
              <c:f>'Sheet 1 - county estimates'!$B$37:$J$37</c:f>
              <c:numCache>
                <c:formatCode>General</c:formatCode>
                <c:ptCount val="9"/>
                <c:pt idx="0">
                  <c:v>0.14826401683000201</c:v>
                </c:pt>
                <c:pt idx="1">
                  <c:v>0.111768005564458</c:v>
                </c:pt>
                <c:pt idx="2">
                  <c:v>0.264220667369022</c:v>
                </c:pt>
                <c:pt idx="3">
                  <c:v>8.6115125712533602E-2</c:v>
                </c:pt>
                <c:pt idx="4">
                  <c:v>6.9430697760870894E-2</c:v>
                </c:pt>
                <c:pt idx="5">
                  <c:v>0.24795964052266101</c:v>
                </c:pt>
                <c:pt idx="6">
                  <c:v>0.15764535619669001</c:v>
                </c:pt>
                <c:pt idx="7">
                  <c:v>0.190056862258976</c:v>
                </c:pt>
                <c:pt idx="8">
                  <c:v>0.561577623429261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C47-044C-852D-FD6BC3521C8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2748320"/>
        <c:axId val="142754552"/>
      </c:barChart>
      <c:catAx>
        <c:axId val="1427483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pPr>
            <a:endParaRPr lang="en-US"/>
          </a:p>
        </c:txPr>
        <c:crossAx val="142754552"/>
        <c:crosses val="autoZero"/>
        <c:auto val="1"/>
        <c:lblAlgn val="ctr"/>
        <c:lblOffset val="100"/>
        <c:noMultiLvlLbl val="0"/>
      </c:catAx>
      <c:valAx>
        <c:axId val="142754552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pPr>
            <a:endParaRPr lang="en-US"/>
          </a:p>
        </c:txPr>
        <c:crossAx val="142748320"/>
        <c:crosses val="autoZero"/>
        <c:crossBetween val="between"/>
        <c:majorUnit val="0.2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45657515174878016"/>
          <c:y val="0.2836999575101605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1" i="0" u="none" strike="noStrike" kern="1200" spc="0" baseline="0">
              <a:solidFill>
                <a:schemeClr val="tx1"/>
              </a:solidFill>
              <a:latin typeface="Calibri" panose="020F0502020204030204" pitchFamily="34" charset="0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heet 1 - county estimates'!$A$35</c:f>
              <c:strCache>
                <c:ptCount val="1"/>
                <c:pt idx="0">
                  <c:v>Haye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heet 1 - county estimates'!$B$71:$J$71</c:f>
                <c:numCache>
                  <c:formatCode>General</c:formatCode>
                  <c:ptCount val="9"/>
                  <c:pt idx="0">
                    <c:v>2.07678953701807E-2</c:v>
                  </c:pt>
                  <c:pt idx="1">
                    <c:v>1.94537587258738E-2</c:v>
                  </c:pt>
                  <c:pt idx="2">
                    <c:v>5.6779513375508399E-2</c:v>
                  </c:pt>
                  <c:pt idx="3">
                    <c:v>1.4769196255286001E-2</c:v>
                  </c:pt>
                  <c:pt idx="4">
                    <c:v>1.5371061792152399E-2</c:v>
                  </c:pt>
                  <c:pt idx="5">
                    <c:v>2.1858071661946799E-2</c:v>
                  </c:pt>
                  <c:pt idx="6">
                    <c:v>4.4962978348149399E-2</c:v>
                  </c:pt>
                  <c:pt idx="7">
                    <c:v>4.4373230231053102E-3</c:v>
                  </c:pt>
                  <c:pt idx="8">
                    <c:v>2.1467584240006402E-2</c:v>
                  </c:pt>
                </c:numCache>
              </c:numRef>
            </c:plus>
            <c:minus>
              <c:numRef>
                <c:f>'Sheet 1 - county estimates'!$B$71:$J$71</c:f>
                <c:numCache>
                  <c:formatCode>General</c:formatCode>
                  <c:ptCount val="9"/>
                  <c:pt idx="0">
                    <c:v>2.07678953701807E-2</c:v>
                  </c:pt>
                  <c:pt idx="1">
                    <c:v>1.94537587258738E-2</c:v>
                  </c:pt>
                  <c:pt idx="2">
                    <c:v>5.6779513375508399E-2</c:v>
                  </c:pt>
                  <c:pt idx="3">
                    <c:v>1.4769196255286001E-2</c:v>
                  </c:pt>
                  <c:pt idx="4">
                    <c:v>1.5371061792152399E-2</c:v>
                  </c:pt>
                  <c:pt idx="5">
                    <c:v>2.1858071661946799E-2</c:v>
                  </c:pt>
                  <c:pt idx="6">
                    <c:v>4.4962978348149399E-2</c:v>
                  </c:pt>
                  <c:pt idx="7">
                    <c:v>4.4373230231053102E-3</c:v>
                  </c:pt>
                  <c:pt idx="8">
                    <c:v>2.146758424000640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heet 1 - county estimates'!$B$34:$J$34</c:f>
              <c:strCache>
                <c:ptCount val="9"/>
                <c:pt idx="0">
                  <c:v>May </c:v>
                </c:pt>
                <c:pt idx="1">
                  <c:v>June    2014</c:v>
                </c:pt>
                <c:pt idx="2">
                  <c:v>July </c:v>
                </c:pt>
                <c:pt idx="3">
                  <c:v>May </c:v>
                </c:pt>
                <c:pt idx="4">
                  <c:v>June    2015</c:v>
                </c:pt>
                <c:pt idx="5">
                  <c:v>July</c:v>
                </c:pt>
                <c:pt idx="6">
                  <c:v>May</c:v>
                </c:pt>
                <c:pt idx="7">
                  <c:v>June    2016</c:v>
                </c:pt>
                <c:pt idx="8">
                  <c:v>July </c:v>
                </c:pt>
              </c:strCache>
            </c:strRef>
          </c:cat>
          <c:val>
            <c:numRef>
              <c:f>'Sheet 1 - county estimates'!$B$35:$J$35</c:f>
              <c:numCache>
                <c:formatCode>General</c:formatCode>
                <c:ptCount val="9"/>
                <c:pt idx="0">
                  <c:v>0.45621730800718002</c:v>
                </c:pt>
                <c:pt idx="1">
                  <c:v>0.39273086399842</c:v>
                </c:pt>
                <c:pt idx="2">
                  <c:v>0.54937975040810405</c:v>
                </c:pt>
                <c:pt idx="3">
                  <c:v>0.273412786296927</c:v>
                </c:pt>
                <c:pt idx="4">
                  <c:v>0.231120839360581</c:v>
                </c:pt>
                <c:pt idx="5">
                  <c:v>0.56924430663198999</c:v>
                </c:pt>
                <c:pt idx="6">
                  <c:v>0.40506610234419799</c:v>
                </c:pt>
                <c:pt idx="7">
                  <c:v>0.54204064879092695</c:v>
                </c:pt>
                <c:pt idx="8">
                  <c:v>0.84663820849048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6D9-D244-A150-84501ABC659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2748320"/>
        <c:axId val="142754552"/>
      </c:barChart>
      <c:catAx>
        <c:axId val="1427483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pPr>
            <a:endParaRPr lang="en-US"/>
          </a:p>
        </c:txPr>
        <c:crossAx val="142754552"/>
        <c:crosses val="autoZero"/>
        <c:auto val="1"/>
        <c:lblAlgn val="ctr"/>
        <c:lblOffset val="100"/>
        <c:noMultiLvlLbl val="0"/>
      </c:catAx>
      <c:valAx>
        <c:axId val="142754552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pPr>
            <a:endParaRPr lang="en-US"/>
          </a:p>
        </c:txPr>
        <c:crossAx val="142748320"/>
        <c:crosses val="autoZero"/>
        <c:crossBetween val="between"/>
        <c:majorUnit val="0.2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000" b="1" i="0" u="none" strike="noStrike" kern="1200" spc="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pPr>
            <a:r>
              <a:rPr lang="en-US" sz="1080" dirty="0">
                <a:solidFill>
                  <a:schemeClr val="tx1"/>
                </a:solidFill>
              </a:rPr>
              <a:t>Furnas</a:t>
            </a:r>
          </a:p>
        </c:rich>
      </c:tx>
      <c:layout>
        <c:manualLayout>
          <c:xMode val="edge"/>
          <c:yMode val="edge"/>
          <c:x val="0.44606514145733051"/>
          <c:y val="0.2035046344669361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1" i="0" u="none" strike="noStrike" kern="1200" spc="0" baseline="0">
              <a:solidFill>
                <a:schemeClr val="tx1"/>
              </a:solidFill>
              <a:latin typeface="Calibri" panose="020F0502020204030204" pitchFamily="34" charset="0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heet 1 - county estimates'!$A$33</c:f>
              <c:strCache>
                <c:ptCount val="1"/>
                <c:pt idx="0">
                  <c:v>Furna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heet 1 - county estimates'!$B$70:$J$70</c:f>
                <c:numCache>
                  <c:formatCode>General</c:formatCode>
                  <c:ptCount val="9"/>
                  <c:pt idx="0">
                    <c:v>1.97789892101096E-2</c:v>
                  </c:pt>
                  <c:pt idx="1">
                    <c:v>1.58351428344966E-2</c:v>
                  </c:pt>
                  <c:pt idx="2">
                    <c:v>8.4774280652639103E-2</c:v>
                  </c:pt>
                  <c:pt idx="3">
                    <c:v>1.4738540411791901E-2</c:v>
                  </c:pt>
                  <c:pt idx="4">
                    <c:v>9.2415048026129598E-3</c:v>
                  </c:pt>
                  <c:pt idx="5">
                    <c:v>2.7250149212312998E-2</c:v>
                  </c:pt>
                  <c:pt idx="6">
                    <c:v>5.4972177208966702E-2</c:v>
                  </c:pt>
                  <c:pt idx="7">
                    <c:v>7.0735165928144401E-3</c:v>
                  </c:pt>
                  <c:pt idx="8">
                    <c:v>3.6431060324635001E-2</c:v>
                  </c:pt>
                </c:numCache>
              </c:numRef>
            </c:plus>
            <c:minus>
              <c:numRef>
                <c:f>'Sheet 1 - county estimates'!$B$70:$J$70</c:f>
                <c:numCache>
                  <c:formatCode>General</c:formatCode>
                  <c:ptCount val="9"/>
                  <c:pt idx="0">
                    <c:v>1.97789892101096E-2</c:v>
                  </c:pt>
                  <c:pt idx="1">
                    <c:v>1.58351428344966E-2</c:v>
                  </c:pt>
                  <c:pt idx="2">
                    <c:v>8.4774280652639103E-2</c:v>
                  </c:pt>
                  <c:pt idx="3">
                    <c:v>1.4738540411791901E-2</c:v>
                  </c:pt>
                  <c:pt idx="4">
                    <c:v>9.2415048026129598E-3</c:v>
                  </c:pt>
                  <c:pt idx="5">
                    <c:v>2.7250149212312998E-2</c:v>
                  </c:pt>
                  <c:pt idx="6">
                    <c:v>5.4972177208966702E-2</c:v>
                  </c:pt>
                  <c:pt idx="7">
                    <c:v>7.0735165928144401E-3</c:v>
                  </c:pt>
                  <c:pt idx="8">
                    <c:v>3.643106032463500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heet 1 - county estimates'!$B$32:$J$32</c:f>
              <c:strCache>
                <c:ptCount val="9"/>
                <c:pt idx="0">
                  <c:v>May </c:v>
                </c:pt>
                <c:pt idx="1">
                  <c:v>June    2014</c:v>
                </c:pt>
                <c:pt idx="2">
                  <c:v>July </c:v>
                </c:pt>
                <c:pt idx="3">
                  <c:v>May </c:v>
                </c:pt>
                <c:pt idx="4">
                  <c:v>June    2015</c:v>
                </c:pt>
                <c:pt idx="5">
                  <c:v>July</c:v>
                </c:pt>
                <c:pt idx="6">
                  <c:v>May</c:v>
                </c:pt>
                <c:pt idx="7">
                  <c:v>June    2016</c:v>
                </c:pt>
                <c:pt idx="8">
                  <c:v>July </c:v>
                </c:pt>
              </c:strCache>
            </c:strRef>
          </c:cat>
          <c:val>
            <c:numRef>
              <c:f>'Sheet 1 - county estimates'!$B$33:$J$33</c:f>
              <c:numCache>
                <c:formatCode>General</c:formatCode>
                <c:ptCount val="9"/>
                <c:pt idx="0">
                  <c:v>0.43718015824857998</c:v>
                </c:pt>
                <c:pt idx="1">
                  <c:v>0.38691566415442202</c:v>
                </c:pt>
                <c:pt idx="2">
                  <c:v>0.441252381571756</c:v>
                </c:pt>
                <c:pt idx="3">
                  <c:v>0.28881173821983103</c:v>
                </c:pt>
                <c:pt idx="4">
                  <c:v>0.25578914903809602</c:v>
                </c:pt>
                <c:pt idx="5">
                  <c:v>0.48272530880709302</c:v>
                </c:pt>
                <c:pt idx="6">
                  <c:v>0.40044399272658099</c:v>
                </c:pt>
                <c:pt idx="7">
                  <c:v>0.53616133686554901</c:v>
                </c:pt>
                <c:pt idx="8">
                  <c:v>0.812710354488883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34B-7645-BBFE-B6EAAF72061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2748320"/>
        <c:axId val="142754552"/>
      </c:barChart>
      <c:catAx>
        <c:axId val="1427483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pPr>
            <a:endParaRPr lang="en-US"/>
          </a:p>
        </c:txPr>
        <c:crossAx val="142754552"/>
        <c:crosses val="autoZero"/>
        <c:auto val="1"/>
        <c:lblAlgn val="ctr"/>
        <c:lblOffset val="100"/>
        <c:noMultiLvlLbl val="0"/>
      </c:catAx>
      <c:valAx>
        <c:axId val="142754552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pPr>
            <a:endParaRPr lang="en-US"/>
          </a:p>
        </c:txPr>
        <c:crossAx val="142748320"/>
        <c:crosses val="autoZero"/>
        <c:crossBetween val="between"/>
        <c:majorUnit val="0.2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19581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89520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62706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4255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09783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3385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8108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83045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4488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64253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05083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26332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B9FFF621-7249-D547-8D75-F6F31E898A3D}"/>
              </a:ext>
            </a:extLst>
          </p:cNvPr>
          <p:cNvGrpSpPr/>
          <p:nvPr/>
        </p:nvGrpSpPr>
        <p:grpSpPr>
          <a:xfrm>
            <a:off x="96801" y="875490"/>
            <a:ext cx="8959516" cy="5337852"/>
            <a:chOff x="79105" y="860500"/>
            <a:chExt cx="8959516" cy="5337852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F2670CF0-F8E0-42F6-92C2-1545FC8F3146}"/>
                </a:ext>
              </a:extLst>
            </p:cNvPr>
            <p:cNvGrpSpPr/>
            <p:nvPr/>
          </p:nvGrpSpPr>
          <p:grpSpPr>
            <a:xfrm>
              <a:off x="555851" y="1002364"/>
              <a:ext cx="8482770" cy="4246253"/>
              <a:chOff x="0" y="36549"/>
              <a:chExt cx="13492298" cy="5760590"/>
            </a:xfrm>
          </p:grpSpPr>
          <p:graphicFrame>
            <p:nvGraphicFramePr>
              <p:cNvPr id="5" name="Chart 4">
                <a:extLst>
                  <a:ext uri="{FF2B5EF4-FFF2-40B4-BE49-F238E27FC236}">
                    <a16:creationId xmlns:a16="http://schemas.microsoft.com/office/drawing/2014/main" id="{B8786C53-8873-4611-B73A-28ED5D6A1237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2732397409"/>
                  </p:ext>
                </p:extLst>
              </p:nvPr>
            </p:nvGraphicFramePr>
            <p:xfrm>
              <a:off x="3518" y="36549"/>
              <a:ext cx="6746149" cy="289464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graphicFrame>
            <p:nvGraphicFramePr>
              <p:cNvPr id="6" name="Chart 5">
                <a:extLst>
                  <a:ext uri="{FF2B5EF4-FFF2-40B4-BE49-F238E27FC236}">
                    <a16:creationId xmlns:a16="http://schemas.microsoft.com/office/drawing/2014/main" id="{DE9BBE20-5626-4E05-B843-67188FCBA899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4090536091"/>
                  </p:ext>
                </p:extLst>
              </p:nvPr>
            </p:nvGraphicFramePr>
            <p:xfrm>
              <a:off x="6746149" y="2904864"/>
              <a:ext cx="6746149" cy="287851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aphicFrame>
            <p:nvGraphicFramePr>
              <p:cNvPr id="7" name="Chart 6">
                <a:extLst>
                  <a:ext uri="{FF2B5EF4-FFF2-40B4-BE49-F238E27FC236}">
                    <a16:creationId xmlns:a16="http://schemas.microsoft.com/office/drawing/2014/main" id="{E396B64C-3959-494A-B956-6B0FCBDC7143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732547978"/>
                  </p:ext>
                </p:extLst>
              </p:nvPr>
            </p:nvGraphicFramePr>
            <p:xfrm>
              <a:off x="6742630" y="36549"/>
              <a:ext cx="6746149" cy="291505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graphicFrame>
            <p:nvGraphicFramePr>
              <p:cNvPr id="8" name="Chart 7">
                <a:extLst>
                  <a:ext uri="{FF2B5EF4-FFF2-40B4-BE49-F238E27FC236}">
                    <a16:creationId xmlns:a16="http://schemas.microsoft.com/office/drawing/2014/main" id="{9406D45A-B059-4F75-9680-EC4A98E218DA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136363521"/>
                  </p:ext>
                </p:extLst>
              </p:nvPr>
            </p:nvGraphicFramePr>
            <p:xfrm>
              <a:off x="0" y="2918618"/>
              <a:ext cx="6746149" cy="2878521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</p:grp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E8D3ABB7-A2FC-1C47-A6B1-6652B7D3C012}"/>
                </a:ext>
              </a:extLst>
            </p:cNvPr>
            <p:cNvSpPr/>
            <p:nvPr/>
          </p:nvSpPr>
          <p:spPr>
            <a:xfrm>
              <a:off x="277939" y="5736687"/>
              <a:ext cx="8754220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>
                <a:tabLst>
                  <a:tab pos="228600" algn="l"/>
                </a:tabLst>
              </a:pPr>
              <a:r>
                <a:rPr lang="en-US" sz="1200" dirty="0"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S4 Figure. Probability of </a:t>
              </a:r>
              <a:r>
                <a:rPr lang="en-US" sz="1200" i="1" dirty="0"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A. </a:t>
              </a:r>
              <a:r>
                <a:rPr lang="en-US" sz="1200" i="1" dirty="0" err="1"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tosichella</a:t>
              </a:r>
              <a:r>
                <a:rPr lang="en-US" sz="1200" dirty="0"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 biotype 1 occurrence (mean </a:t>
              </a:r>
              <a:r>
                <a:rPr lang="en-US" sz="1200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± SE</a:t>
              </a:r>
              <a:r>
                <a:rPr lang="en-US" sz="1200" dirty="0"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) at locations in Cheyenne (A), Hayes (B), Furnas and Saunders (D)  county Nebraska in 2014, 2015 and 2016.</a:t>
              </a:r>
              <a:endPara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 Box 16">
              <a:extLst>
                <a:ext uri="{FF2B5EF4-FFF2-40B4-BE49-F238E27FC236}">
                  <a16:creationId xmlns:a16="http://schemas.microsoft.com/office/drawing/2014/main" id="{309FB0DE-D32E-7F45-9519-7707D20C9089}"/>
                </a:ext>
              </a:extLst>
            </p:cNvPr>
            <p:cNvSpPr txBox="1"/>
            <p:nvPr/>
          </p:nvSpPr>
          <p:spPr>
            <a:xfrm>
              <a:off x="3969306" y="5317233"/>
              <a:ext cx="2067801" cy="267176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txBody>
            <a:bodyPr rot="0" spcFirstLastPara="0" vert="horz" wrap="square" lIns="68580" tIns="34290" rIns="68580" bIns="3429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400" b="1" dirty="0"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Sample Month and Year</a:t>
              </a:r>
              <a:endPara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endParaRPr>
            </a:p>
          </p:txBody>
        </p:sp>
        <p:sp>
          <p:nvSpPr>
            <p:cNvPr id="11" name="Text Box 18">
              <a:extLst>
                <a:ext uri="{FF2B5EF4-FFF2-40B4-BE49-F238E27FC236}">
                  <a16:creationId xmlns:a16="http://schemas.microsoft.com/office/drawing/2014/main" id="{B739D434-6B5C-AE48-8652-C5EA13703E49}"/>
                </a:ext>
              </a:extLst>
            </p:cNvPr>
            <p:cNvSpPr txBox="1"/>
            <p:nvPr/>
          </p:nvSpPr>
          <p:spPr>
            <a:xfrm rot="10800000">
              <a:off x="79105" y="860500"/>
              <a:ext cx="397669" cy="4695825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txBody>
            <a:bodyPr rot="0" spcFirstLastPara="0" vert="eaVert" wrap="square" lIns="68580" tIns="34290" rIns="68580" bIns="3429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400" b="1" dirty="0"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Probability of </a:t>
              </a:r>
              <a:r>
                <a:rPr lang="en-US" sz="1400" b="1" i="1" dirty="0"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A. </a:t>
              </a:r>
              <a:r>
                <a:rPr lang="en-US" sz="1400" b="1" i="1" dirty="0" err="1"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toschiella</a:t>
              </a:r>
              <a:r>
                <a:rPr lang="en-US" sz="1400" b="1" dirty="0"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 biotype 1 occurrence (mean </a:t>
              </a:r>
              <a:r>
                <a:rPr lang="en-US" sz="140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± </a:t>
              </a:r>
              <a:r>
                <a:rPr lang="en-US" sz="1400" b="1" dirty="0"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SE)</a:t>
              </a:r>
              <a:endPara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E17810CD-ED43-0C49-B2F3-E1E8B1C7AE27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981564" y="1245023"/>
              <a:ext cx="300044" cy="260907"/>
            </a:xfrm>
            <a:prstGeom prst="rect">
              <a:avLst/>
            </a:prstGeom>
            <a:noFill/>
            <a:ln w="2667">
              <a:noFill/>
            </a:ln>
          </p:spPr>
          <p:txBody>
            <a:bodyPr wrap="none">
              <a:noAutofit/>
            </a:bodyPr>
            <a:lstStyle/>
            <a:p>
              <a:pPr algn="ctr"/>
              <a:r>
                <a:rPr lang="en-US" sz="1200" b="1" dirty="0">
                  <a:solidFill>
                    <a:srgbClr val="000000"/>
                  </a:solidFill>
                  <a:latin typeface="Calibri" panose="020F0502020204030204" pitchFamily="34" charset="0"/>
                  <a:ea typeface="PMingLiU" panose="02020500000000000000" pitchFamily="18" charset="-120"/>
                  <a:cs typeface="Calibri" panose="020F0502020204030204" pitchFamily="34" charset="0"/>
                </a:rPr>
                <a:t>A</a:t>
              </a:r>
              <a:endParaRPr lang="en-US" sz="16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0A6CEF86-6C0B-7C44-A55C-FD1852612F82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249410" y="1253282"/>
              <a:ext cx="273583" cy="244391"/>
            </a:xfrm>
            <a:prstGeom prst="rect">
              <a:avLst/>
            </a:prstGeom>
            <a:noFill/>
            <a:ln w="1270">
              <a:noFill/>
            </a:ln>
          </p:spPr>
          <p:txBody>
            <a:bodyPr wrap="none">
              <a:noAutofit/>
            </a:bodyPr>
            <a:lstStyle/>
            <a:p>
              <a:pPr algn="ctr"/>
              <a:r>
                <a:rPr lang="en-US" sz="1200" b="1" dirty="0">
                  <a:solidFill>
                    <a:srgbClr val="000000"/>
                  </a:solidFill>
                  <a:latin typeface="Calibri" panose="020F0502020204030204" pitchFamily="34" charset="0"/>
                  <a:ea typeface="PMingLiU" panose="02020500000000000000" pitchFamily="18" charset="-120"/>
                  <a:cs typeface="Calibri" panose="020F0502020204030204" pitchFamily="34" charset="0"/>
                </a:rPr>
                <a:t>B</a:t>
              </a:r>
              <a:endParaRPr lang="en-US" sz="16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4085D1A7-D7FF-ED48-9232-DA91D7839AF4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017147" y="3399526"/>
              <a:ext cx="241717" cy="218638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none">
              <a:noAutofit/>
            </a:bodyPr>
            <a:lstStyle/>
            <a:p>
              <a:pPr algn="ctr"/>
              <a:r>
                <a:rPr lang="en-US" sz="1200" b="1" dirty="0">
                  <a:solidFill>
                    <a:srgbClr val="000000"/>
                  </a:solidFill>
                  <a:latin typeface="Calibri" panose="020F0502020204030204" pitchFamily="34" charset="0"/>
                  <a:ea typeface="PMingLiU" panose="02020500000000000000" pitchFamily="18" charset="-120"/>
                  <a:cs typeface="Calibri" panose="020F0502020204030204" pitchFamily="34" charset="0"/>
                </a:rPr>
                <a:t>C</a:t>
              </a:r>
              <a:endParaRPr lang="en-US" sz="16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C3EAC843-9B5B-334A-AB04-EE59BE5F085B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040890" y="3372298"/>
              <a:ext cx="690622" cy="624682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none">
              <a:noAutofit/>
            </a:bodyPr>
            <a:lstStyle/>
            <a:p>
              <a:pPr algn="ctr"/>
              <a:r>
                <a:rPr lang="en-US" sz="1200" b="1" dirty="0">
                  <a:solidFill>
                    <a:srgbClr val="000000"/>
                  </a:solidFill>
                  <a:latin typeface="Calibri" panose="020F0502020204030204" pitchFamily="34" charset="0"/>
                  <a:ea typeface="PMingLiU" panose="02020500000000000000" pitchFamily="18" charset="-120"/>
                  <a:cs typeface="Calibri" panose="020F0502020204030204" pitchFamily="34" charset="0"/>
                </a:rPr>
                <a:t>D</a:t>
              </a:r>
              <a:endParaRPr lang="en-US" sz="16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0899289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2</TotalTime>
  <Words>67</Words>
  <Application>Microsoft Macintosh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 Smith</dc:creator>
  <cp:lastModifiedBy>Microsoft Office User</cp:lastModifiedBy>
  <cp:revision>7</cp:revision>
  <dcterms:created xsi:type="dcterms:W3CDTF">2019-11-04T20:35:29Z</dcterms:created>
  <dcterms:modified xsi:type="dcterms:W3CDTF">2020-04-10T15:47:16Z</dcterms:modified>
</cp:coreProperties>
</file>